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52"/>
    <p:restoredTop sz="94079"/>
  </p:normalViewPr>
  <p:slideViewPr>
    <p:cSldViewPr snapToGrid="0">
      <p:cViewPr varScale="1">
        <p:scale>
          <a:sx n="42" d="100"/>
          <a:sy n="42" d="100"/>
        </p:scale>
        <p:origin x="66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A31393F-5709-4AD2-BAB9-1BE7C507B62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D0C1ADA0-A89E-4B50-91FF-969A5DC016B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172E7F0-B4EA-463D-A338-E1015DE810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DF417-FDFC-4656-B6BC-FC02AFF79451}" type="datetimeFigureOut">
              <a:rPr lang="it-IT" smtClean="0"/>
              <a:t>06/05/2020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2A4E1C4-24C3-4F00-B6C7-AECE557657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D242D66-A4D1-499F-B1BB-A68CF3DA54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04E38-2889-4A5B-8C67-67D6161D068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658882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29DC8E2-DF2B-4C71-9BD2-302BD16CC4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59CAC998-1E3A-4091-B4B7-98EE36963CC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FAD3EC1-9A13-4460-B5D9-80EA939A11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DF417-FDFC-4656-B6BC-FC02AFF79451}" type="datetimeFigureOut">
              <a:rPr lang="it-IT" smtClean="0"/>
              <a:t>06/05/2020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7130D93-ED3C-4254-B282-3EE5A83B02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7BE98C3-0BEE-4DD1-BDD4-9E60ED7B57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04E38-2889-4A5B-8C67-67D6161D068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388958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AB4A4413-70DE-4076-82F0-FF881DF8B38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2B994DBA-14FE-4B83-96C4-1FFBF4213EC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D28814E-98CC-451D-96D6-CE1928D4BB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DF417-FDFC-4656-B6BC-FC02AFF79451}" type="datetimeFigureOut">
              <a:rPr lang="it-IT" smtClean="0"/>
              <a:t>06/05/2020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9BB6377-8B53-4367-AC82-768BB16D2B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68D5D80-C925-44D6-B948-FF796400F0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04E38-2889-4A5B-8C67-67D6161D068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68429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DB973CF-ABF0-4DC7-B925-43CCD3681A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482D6CF-CC91-48B9-9B19-3184A28E436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288C7B7-A565-4ADF-8F56-28BEEDB8E3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DF417-FDFC-4656-B6BC-FC02AFF79451}" type="datetimeFigureOut">
              <a:rPr lang="it-IT" smtClean="0"/>
              <a:t>06/05/2020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0754E2D-846A-4E4B-A691-99215FEAAF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FBBE2D4-B408-495E-8892-AC7A9CF688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04E38-2889-4A5B-8C67-67D6161D068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431155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BF2EE1D-94FB-4922-9331-A16C70D1E7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04EBEA86-8951-4712-8309-F6F2B6D870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DED17C6-468A-49BB-8F19-4CAD7848F3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DF417-FDFC-4656-B6BC-FC02AFF79451}" type="datetimeFigureOut">
              <a:rPr lang="it-IT" smtClean="0"/>
              <a:t>06/05/2020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11DDE34-541F-477C-A50E-6FA3EF9096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F2D8F2E-249F-4940-AFE8-B1A30F2D49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04E38-2889-4A5B-8C67-67D6161D068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388811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8121F94-721F-45F7-891D-70F679B63C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55D7FFF9-CDA7-4A03-A7D7-1C9B221D372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5DBC02E1-1090-4CF6-93E2-D86797437F9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86E2C140-F7A5-4DE5-83B0-9EE78CA9E5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DF417-FDFC-4656-B6BC-FC02AFF79451}" type="datetimeFigureOut">
              <a:rPr lang="it-IT" smtClean="0"/>
              <a:t>06/05/2020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84A0F6D6-B516-47A3-8D59-91C0E81F95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D5CB3CA-10BA-45EF-978D-01D2F8633D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04E38-2889-4A5B-8C67-67D6161D068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13132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AF2D4EA-09FA-4009-B51F-D8D26323B6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170ED8BE-F860-47AC-B58D-AC4125E4D0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3AEC240E-49BC-4277-99AB-77F3D3BDC0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F0439224-1608-42A0-9431-AF6E11FE041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262AB3BB-E7AF-4C00-914A-B94F7851D51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D90B944D-F13B-4D1F-B19E-9B2B77D20F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DF417-FDFC-4656-B6BC-FC02AFF79451}" type="datetimeFigureOut">
              <a:rPr lang="it-IT" smtClean="0"/>
              <a:t>06/05/2020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EEB929D7-BD30-4043-9434-39F6492D81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2D16814C-38CA-4455-AB38-9FD9AD95A8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04E38-2889-4A5B-8C67-67D6161D068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907382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BDF2DCC-E76B-435D-8B48-43F93AFE0E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A90DEB58-3198-47E9-9018-E9511FC463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DF417-FDFC-4656-B6BC-FC02AFF79451}" type="datetimeFigureOut">
              <a:rPr lang="it-IT" smtClean="0"/>
              <a:t>06/05/2020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DCA0D478-124B-4B48-A504-DCCA8F0C31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1D1B6430-8321-4F2D-8988-A80131C8E3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04E38-2889-4A5B-8C67-67D6161D068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138604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4EEDB270-DF9C-45E7-BE86-9D10F22D30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DF417-FDFC-4656-B6BC-FC02AFF79451}" type="datetimeFigureOut">
              <a:rPr lang="it-IT" smtClean="0"/>
              <a:t>06/05/2020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F41BAFEC-959D-46A6-AA6A-6558ED84C4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2FCCA2B1-AC40-4CFE-B50F-F6C3EDE2A3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04E38-2889-4A5B-8C67-67D6161D068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833976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9B0A7EC-B2E9-4871-B1C4-0AD5653D43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C21B16A-5607-4D2D-B4CE-92ACDC0B466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366876A9-65B7-44F4-BE2B-629392D329B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5F778E70-CD40-4725-9A0C-4C34B4D512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DF417-FDFC-4656-B6BC-FC02AFF79451}" type="datetimeFigureOut">
              <a:rPr lang="it-IT" smtClean="0"/>
              <a:t>06/05/2020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68E8084F-B9ED-4313-AAAF-3BA342533A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8CE4AF21-C02C-4E7A-808D-88082D7680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04E38-2889-4A5B-8C67-67D6161D068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249181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936F8A7-6BC4-4F27-9974-41CE5508C2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86328D4B-75A5-4CA4-9166-DD75C0A7ACE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59C0110F-8A11-4C81-9A84-1205A373119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C6FDC1BD-9E29-4337-A5A6-18ACE22969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DF417-FDFC-4656-B6BC-FC02AFF79451}" type="datetimeFigureOut">
              <a:rPr lang="it-IT" smtClean="0"/>
              <a:t>06/05/2020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F4DAA663-4A48-4D88-AD6E-118E98C0D2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3064E78E-BF4C-46C8-901A-6F06D5E0D4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04E38-2889-4A5B-8C67-67D6161D068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994536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8B13B47C-E9C8-4A70-822E-D220397489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57A5BCA3-54B3-4272-B35E-9A40F0E034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12E48DA-4F5E-46BA-8A10-A1D6B9E62FD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EDF417-FDFC-4656-B6BC-FC02AFF79451}" type="datetimeFigureOut">
              <a:rPr lang="it-IT" smtClean="0"/>
              <a:t>06/05/2020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0B55FF2-953A-4091-A457-E442E519550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96053FA-8540-4147-BE90-B6E0316D068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804E38-2889-4A5B-8C67-67D6161D068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457435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 descr="Immagine che contiene testo&#10;&#10;Descrizione generata automaticamente">
            <a:extLst>
              <a:ext uri="{FF2B5EF4-FFF2-40B4-BE49-F238E27FC236}">
                <a16:creationId xmlns:a16="http://schemas.microsoft.com/office/drawing/2014/main" id="{66D53CAD-548D-4990-85AC-8417577C63A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6305" y="846000"/>
            <a:ext cx="8379389" cy="6012000"/>
          </a:xfrm>
          <a:prstGeom prst="rect">
            <a:avLst/>
          </a:prstGeom>
        </p:spPr>
      </p:pic>
      <p:sp>
        <p:nvSpPr>
          <p:cNvPr id="6" name="CasellaDiTesto 5">
            <a:extLst>
              <a:ext uri="{FF2B5EF4-FFF2-40B4-BE49-F238E27FC236}">
                <a16:creationId xmlns:a16="http://schemas.microsoft.com/office/drawing/2014/main" id="{032ED028-2A23-4576-B910-BC10F8D6EE24}"/>
              </a:ext>
            </a:extLst>
          </p:cNvPr>
          <p:cNvSpPr txBox="1"/>
          <p:nvPr/>
        </p:nvSpPr>
        <p:spPr>
          <a:xfrm>
            <a:off x="451977" y="415113"/>
            <a:ext cx="1136488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it-IT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S3 -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near regression analysis between the yield per plant (YP) and the environmental index (EI) over four experimental trials in 12 genotypes. </a:t>
            </a:r>
            <a:r>
              <a:rPr lang="en-US" sz="1100">
                <a:latin typeface="Times New Roman" panose="02020603050405020304" pitchFamily="18" charset="0"/>
                <a:cs typeface="Times New Roman" panose="02020603050405020304" pitchFamily="18" charset="0"/>
              </a:rPr>
              <a:t>YP is the mean value of yield over the four trials and the formula for calculating the EI is reported in the paragraph Materials and methods</a:t>
            </a:r>
            <a:endParaRPr lang="it-IT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8973465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6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abrizio Olivieri</dc:creator>
  <cp:lastModifiedBy>Fabrizio Olivieri</cp:lastModifiedBy>
  <cp:revision>3</cp:revision>
  <dcterms:created xsi:type="dcterms:W3CDTF">2020-05-06T12:12:24Z</dcterms:created>
  <dcterms:modified xsi:type="dcterms:W3CDTF">2020-05-06T13:27:40Z</dcterms:modified>
</cp:coreProperties>
</file>